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60" r:id="rId5"/>
    <p:sldId id="259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10" d="100"/>
          <a:sy n="110" d="100"/>
        </p:scale>
        <p:origin x="59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EAB19-A3E8-4E5C-845B-FD819BFF75FF}" type="datetimeFigureOut">
              <a:rPr lang="en-US" smtClean="0"/>
              <a:t>12/1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C994A8-5FDB-41DE-8A73-35AFD40F69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68384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EAB19-A3E8-4E5C-845B-FD819BFF75FF}" type="datetimeFigureOut">
              <a:rPr lang="en-US" smtClean="0"/>
              <a:t>12/1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C994A8-5FDB-41DE-8A73-35AFD40F69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43873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EAB19-A3E8-4E5C-845B-FD819BFF75FF}" type="datetimeFigureOut">
              <a:rPr lang="en-US" smtClean="0"/>
              <a:t>12/1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C994A8-5FDB-41DE-8A73-35AFD40F69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24543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EAB19-A3E8-4E5C-845B-FD819BFF75FF}" type="datetimeFigureOut">
              <a:rPr lang="en-US" smtClean="0"/>
              <a:t>12/1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C994A8-5FDB-41DE-8A73-35AFD40F69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69661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EAB19-A3E8-4E5C-845B-FD819BFF75FF}" type="datetimeFigureOut">
              <a:rPr lang="en-US" smtClean="0"/>
              <a:t>12/1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C994A8-5FDB-41DE-8A73-35AFD40F69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24709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EAB19-A3E8-4E5C-845B-FD819BFF75FF}" type="datetimeFigureOut">
              <a:rPr lang="en-US" smtClean="0"/>
              <a:t>12/1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C994A8-5FDB-41DE-8A73-35AFD40F69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47655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EAB19-A3E8-4E5C-845B-FD819BFF75FF}" type="datetimeFigureOut">
              <a:rPr lang="en-US" smtClean="0"/>
              <a:t>12/19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C994A8-5FDB-41DE-8A73-35AFD40F69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92709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EAB19-A3E8-4E5C-845B-FD819BFF75FF}" type="datetimeFigureOut">
              <a:rPr lang="en-US" smtClean="0"/>
              <a:t>12/19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C994A8-5FDB-41DE-8A73-35AFD40F69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63488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EAB19-A3E8-4E5C-845B-FD819BFF75FF}" type="datetimeFigureOut">
              <a:rPr lang="en-US" smtClean="0"/>
              <a:t>12/19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C994A8-5FDB-41DE-8A73-35AFD40F69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32249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EAB19-A3E8-4E5C-845B-FD819BFF75FF}" type="datetimeFigureOut">
              <a:rPr lang="en-US" smtClean="0"/>
              <a:t>12/1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C994A8-5FDB-41DE-8A73-35AFD40F69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6611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9EAB19-A3E8-4E5C-845B-FD819BFF75FF}" type="datetimeFigureOut">
              <a:rPr lang="en-US" smtClean="0"/>
              <a:t>12/1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C994A8-5FDB-41DE-8A73-35AFD40F69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4767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9EAB19-A3E8-4E5C-845B-FD819BFF75FF}" type="datetimeFigureOut">
              <a:rPr lang="en-US" smtClean="0"/>
              <a:t>12/1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C994A8-5FDB-41DE-8A73-35AFD40F69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4365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9.jpeg"/><Relationship Id="rId4" Type="http://schemas.openxmlformats.org/officeDocument/2006/relationships/image" Target="../media/image8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g"/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2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g"/><Relationship Id="rId7" Type="http://schemas.openxmlformats.org/officeDocument/2006/relationships/image" Target="../media/image18.jpeg"/><Relationship Id="rId2" Type="http://schemas.openxmlformats.org/officeDocument/2006/relationships/image" Target="../media/image13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jpeg"/><Relationship Id="rId5" Type="http://schemas.openxmlformats.org/officeDocument/2006/relationships/image" Target="../media/image16.jpg"/><Relationship Id="rId4" Type="http://schemas.openxmlformats.org/officeDocument/2006/relationships/image" Target="../media/image15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22217" y="165463"/>
            <a:ext cx="15501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2C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57042" y="1841155"/>
            <a:ext cx="2097024" cy="2670048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41085" y="1820526"/>
            <a:ext cx="3271997" cy="2711305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88999" y="1489166"/>
            <a:ext cx="2780106" cy="321085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2386149" y="4885509"/>
            <a:ext cx="9405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MP-2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6021977" y="4885509"/>
            <a:ext cx="9405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CP-1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9187542" y="4885509"/>
            <a:ext cx="9405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Oval 10"/>
          <p:cNvSpPr/>
          <p:nvPr/>
        </p:nvSpPr>
        <p:spPr>
          <a:xfrm>
            <a:off x="5490752" y="2144215"/>
            <a:ext cx="888274" cy="2429691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10089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22217" y="165463"/>
            <a:ext cx="15501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3A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56832" y="1789612"/>
            <a:ext cx="1682496" cy="301752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73249" y="705394"/>
            <a:ext cx="3375589" cy="4682626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3172769" y="5721532"/>
            <a:ext cx="23049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K1 and NLK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7201988" y="5721532"/>
            <a:ext cx="9405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Oval 6"/>
          <p:cNvSpPr/>
          <p:nvPr/>
        </p:nvSpPr>
        <p:spPr>
          <a:xfrm>
            <a:off x="3200320" y="1871560"/>
            <a:ext cx="650796" cy="1780120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Oval 7"/>
          <p:cNvSpPr/>
          <p:nvPr/>
        </p:nvSpPr>
        <p:spPr>
          <a:xfrm>
            <a:off x="4056436" y="717676"/>
            <a:ext cx="650796" cy="1780120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254671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557554" y="296093"/>
            <a:ext cx="15501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3C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474617" y="317863"/>
            <a:ext cx="15501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3B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6738" y="1481939"/>
            <a:ext cx="1338623" cy="3053838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71234" y="1442080"/>
            <a:ext cx="1888652" cy="3190684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93170" y="1510503"/>
            <a:ext cx="1652407" cy="3025274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47157" y="1510503"/>
            <a:ext cx="2608056" cy="3053838"/>
          </a:xfrm>
          <a:prstGeom prst="rect">
            <a:avLst/>
          </a:prstGeom>
        </p:spPr>
      </p:pic>
      <p:sp>
        <p:nvSpPr>
          <p:cNvPr id="8" name="Oval 7"/>
          <p:cNvSpPr/>
          <p:nvPr/>
        </p:nvSpPr>
        <p:spPr>
          <a:xfrm>
            <a:off x="7910484" y="2264229"/>
            <a:ext cx="888274" cy="2368535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602563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22217" y="165463"/>
            <a:ext cx="15501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4F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584"/>
          <a:stretch/>
        </p:blipFill>
        <p:spPr>
          <a:xfrm>
            <a:off x="5684765" y="1296596"/>
            <a:ext cx="2396844" cy="4227793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06691" y="2449768"/>
            <a:ext cx="1203960" cy="2599025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9090" y="1296596"/>
            <a:ext cx="3642253" cy="4264805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2595154" y="5738949"/>
            <a:ext cx="9405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MP-2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6230982" y="5738949"/>
            <a:ext cx="9405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CP-1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9396547" y="5738949"/>
            <a:ext cx="9405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Oval 10"/>
          <p:cNvSpPr/>
          <p:nvPr/>
        </p:nvSpPr>
        <p:spPr>
          <a:xfrm rot="5400000">
            <a:off x="2443030" y="3743765"/>
            <a:ext cx="1313186" cy="2248066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271242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479175" y="348347"/>
            <a:ext cx="15501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4C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474617" y="317863"/>
            <a:ext cx="15501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4B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4499" y="1262741"/>
            <a:ext cx="1237488" cy="2584704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90970" y="1262741"/>
            <a:ext cx="1112377" cy="2650889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61954" y="1262741"/>
            <a:ext cx="1881549" cy="2650889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93836" y="1253160"/>
            <a:ext cx="1554480" cy="2670048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79175" y="1262740"/>
            <a:ext cx="1235867" cy="2650889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260311" y="1253159"/>
            <a:ext cx="1362781" cy="2662093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931794" y="4053659"/>
            <a:ext cx="9405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rc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2562822" y="4057834"/>
            <a:ext cx="9405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K1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193850" y="4055083"/>
            <a:ext cx="9405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LK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6774517" y="4053659"/>
            <a:ext cx="9405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Kit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10597982" y="4053659"/>
            <a:ext cx="9405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LK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8799988" y="4043134"/>
            <a:ext cx="9405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rc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998632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30</Words>
  <Application>Microsoft Office PowerPoint</Application>
  <PresentationFormat>Widescreen</PresentationFormat>
  <Paragraphs>21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MIAMI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ng, Lei</dc:creator>
  <cp:lastModifiedBy>Song, Lei</cp:lastModifiedBy>
  <cp:revision>2</cp:revision>
  <dcterms:created xsi:type="dcterms:W3CDTF">2016-12-20T00:29:22Z</dcterms:created>
  <dcterms:modified xsi:type="dcterms:W3CDTF">2016-12-20T00:41:04Z</dcterms:modified>
</cp:coreProperties>
</file>